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6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36" d="100"/>
          <a:sy n="36" d="100"/>
        </p:scale>
        <p:origin x="193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529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357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620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046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796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124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31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049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259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803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360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07D87A-786D-4E4C-8010-EDEBBC1203A8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DA839C-92A9-404A-9449-3A6387DBE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122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Tif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0" Type="http://schemas.microsoft.com/office/2007/relationships/hdphoto" Target="../media/hdphoto4.wdp"/><Relationship Id="rId4" Type="http://schemas.openxmlformats.org/officeDocument/2006/relationships/image" Target="../media/image2.Tif"/><Relationship Id="rId9" Type="http://schemas.openxmlformats.org/officeDocument/2006/relationships/image" Target="../media/image5.png"/><Relationship Id="rId14" Type="http://schemas.openxmlformats.org/officeDocument/2006/relationships/image" Target="../media/image8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microsoft.com/office/2007/relationships/hdphoto" Target="../media/hdphoto6.wdp"/><Relationship Id="rId7" Type="http://schemas.microsoft.com/office/2007/relationships/hdphoto" Target="../media/hdphoto8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11" Type="http://schemas.microsoft.com/office/2007/relationships/hdphoto" Target="../media/hdphoto10.wdp"/><Relationship Id="rId5" Type="http://schemas.microsoft.com/office/2007/relationships/hdphoto" Target="../media/hdphoto7.wdp"/><Relationship Id="rId10" Type="http://schemas.openxmlformats.org/officeDocument/2006/relationships/image" Target="../media/image13.png"/><Relationship Id="rId4" Type="http://schemas.openxmlformats.org/officeDocument/2006/relationships/image" Target="../media/image10.png"/><Relationship Id="rId9" Type="http://schemas.microsoft.com/office/2007/relationships/hdphoto" Target="../media/hdphoto9.wdp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3.wdp"/><Relationship Id="rId13" Type="http://schemas.openxmlformats.org/officeDocument/2006/relationships/image" Target="../media/image21.Tif"/><Relationship Id="rId3" Type="http://schemas.microsoft.com/office/2007/relationships/hdphoto" Target="../media/hdphoto11.wdp"/><Relationship Id="rId7" Type="http://schemas.openxmlformats.org/officeDocument/2006/relationships/image" Target="../media/image17.png"/><Relationship Id="rId12" Type="http://schemas.openxmlformats.org/officeDocument/2006/relationships/image" Target="../media/image20.Tif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"/><Relationship Id="rId11" Type="http://schemas.openxmlformats.org/officeDocument/2006/relationships/image" Target="../media/image19.png"/><Relationship Id="rId5" Type="http://schemas.microsoft.com/office/2007/relationships/hdphoto" Target="../media/hdphoto12.wdp"/><Relationship Id="rId10" Type="http://schemas.microsoft.com/office/2007/relationships/hdphoto" Target="../media/hdphoto14.wdp"/><Relationship Id="rId4" Type="http://schemas.openxmlformats.org/officeDocument/2006/relationships/image" Target="../media/image15.png"/><Relationship Id="rId9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5139D4D6-19AB-426F-86A0-14901EFF059E}"/>
              </a:ext>
            </a:extLst>
          </p:cNvPr>
          <p:cNvSpPr txBox="1"/>
          <p:nvPr/>
        </p:nvSpPr>
        <p:spPr>
          <a:xfrm>
            <a:off x="0" y="22838"/>
            <a:ext cx="2044148" cy="41966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27" b="1" dirty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optosis </a:t>
            </a:r>
            <a:endParaRPr lang="he-IL" sz="2127" b="1" dirty="0">
              <a:solidFill>
                <a:srgbClr val="3333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" name="Group 32"/>
          <p:cNvGrpSpPr/>
          <p:nvPr/>
        </p:nvGrpSpPr>
        <p:grpSpPr>
          <a:xfrm>
            <a:off x="-380779" y="419074"/>
            <a:ext cx="3720505" cy="2859879"/>
            <a:chOff x="-957105" y="935090"/>
            <a:chExt cx="4163510" cy="3200409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A51DB498-A987-4DFE-86F9-0AA1844974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30" t="17028" r="61244" b="35444"/>
            <a:stretch/>
          </p:blipFill>
          <p:spPr>
            <a:xfrm>
              <a:off x="538861" y="1479675"/>
              <a:ext cx="1319149" cy="2655824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08B0E008-7125-4B08-8CAC-6A466C057A35}"/>
                </a:ext>
              </a:extLst>
            </p:cNvPr>
            <p:cNvSpPr/>
            <p:nvPr/>
          </p:nvSpPr>
          <p:spPr>
            <a:xfrm>
              <a:off x="126800" y="935090"/>
              <a:ext cx="3079605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ADC802FA-B3E9-41CA-AD4F-5304EE6ADB10}"/>
                </a:ext>
              </a:extLst>
            </p:cNvPr>
            <p:cNvSpPr/>
            <p:nvPr/>
          </p:nvSpPr>
          <p:spPr>
            <a:xfrm>
              <a:off x="577118" y="1185112"/>
              <a:ext cx="16498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  7.5       15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FF89320A-DABF-4EC9-B02E-34768A249976}"/>
                </a:ext>
              </a:extLst>
            </p:cNvPr>
            <p:cNvSpPr/>
            <p:nvPr/>
          </p:nvSpPr>
          <p:spPr>
            <a:xfrm>
              <a:off x="1858010" y="2275797"/>
              <a:ext cx="641388" cy="3542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  </a:t>
              </a:r>
              <a:endParaRPr lang="he-IL" sz="170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A491B5EF-75D1-4133-8FD7-9AA103B97C53}"/>
                </a:ext>
              </a:extLst>
            </p:cNvPr>
            <p:cNvSpPr/>
            <p:nvPr/>
          </p:nvSpPr>
          <p:spPr>
            <a:xfrm>
              <a:off x="-957105" y="2303401"/>
              <a:ext cx="1524867" cy="321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pase-9</a:t>
              </a: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2111175" y="399593"/>
            <a:ext cx="3311677" cy="2866377"/>
            <a:chOff x="1515823" y="442505"/>
            <a:chExt cx="3706003" cy="3207680"/>
          </a:xfrm>
        </p:grpSpPr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B2256BC4-AED1-468E-9FBD-B883188DF588}"/>
                </a:ext>
              </a:extLst>
            </p:cNvPr>
            <p:cNvSpPr/>
            <p:nvPr/>
          </p:nvSpPr>
          <p:spPr>
            <a:xfrm>
              <a:off x="1515823" y="1892757"/>
              <a:ext cx="1067548" cy="3542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IF</a:t>
              </a:r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endParaRPr lang="he-IL" sz="170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3E0B94D4-5FB8-4571-87F4-3D7391B87078}"/>
                </a:ext>
              </a:extLst>
            </p:cNvPr>
            <p:cNvSpPr/>
            <p:nvPr/>
          </p:nvSpPr>
          <p:spPr>
            <a:xfrm>
              <a:off x="3586360" y="1818087"/>
              <a:ext cx="618733" cy="3542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5   </a:t>
              </a:r>
              <a:endParaRPr lang="he-IL" sz="170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D1AB0623-D450-4DE6-AEC2-90364378D6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217" t="20489" r="36184" b="46551"/>
            <a:stretch/>
          </p:blipFill>
          <p:spPr>
            <a:xfrm>
              <a:off x="2562184" y="1044041"/>
              <a:ext cx="1060533" cy="2606144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08B0E008-7125-4B08-8CAC-6A466C057A35}"/>
                </a:ext>
              </a:extLst>
            </p:cNvPr>
            <p:cNvSpPr/>
            <p:nvPr/>
          </p:nvSpPr>
          <p:spPr>
            <a:xfrm>
              <a:off x="2142221" y="442505"/>
              <a:ext cx="3079605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ADC802FA-B3E9-41CA-AD4F-5304EE6ADB10}"/>
                </a:ext>
              </a:extLst>
            </p:cNvPr>
            <p:cNvSpPr/>
            <p:nvPr/>
          </p:nvSpPr>
          <p:spPr>
            <a:xfrm>
              <a:off x="2570563" y="728117"/>
              <a:ext cx="149592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7.5     15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grpSp>
        <p:nvGrpSpPr>
          <p:cNvPr id="44" name="Group 43"/>
          <p:cNvGrpSpPr/>
          <p:nvPr/>
        </p:nvGrpSpPr>
        <p:grpSpPr>
          <a:xfrm>
            <a:off x="4341019" y="406820"/>
            <a:ext cx="3148677" cy="2894002"/>
            <a:chOff x="3835299" y="467767"/>
            <a:chExt cx="3523594" cy="3238595"/>
          </a:xfrm>
        </p:grpSpPr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8A960799-9B55-4BCE-BE2D-18845D121D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00" t="18473" r="39283" b="35777"/>
            <a:stretch/>
          </p:blipFill>
          <p:spPr>
            <a:xfrm>
              <a:off x="4561148" y="1044041"/>
              <a:ext cx="1202458" cy="2662321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F47C8DF7-F0EE-43F1-9710-15D719F85C12}"/>
                </a:ext>
              </a:extLst>
            </p:cNvPr>
            <p:cNvSpPr/>
            <p:nvPr/>
          </p:nvSpPr>
          <p:spPr>
            <a:xfrm>
              <a:off x="3835299" y="2545686"/>
              <a:ext cx="767431" cy="3964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x</a:t>
              </a:r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endParaRPr lang="he-IL" sz="170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1E7D7EAD-0B4E-494E-ACE0-A74A4E2BE650}"/>
                </a:ext>
              </a:extLst>
            </p:cNvPr>
            <p:cNvSpPr/>
            <p:nvPr/>
          </p:nvSpPr>
          <p:spPr>
            <a:xfrm>
              <a:off x="5819091" y="2594259"/>
              <a:ext cx="758171" cy="3542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7   </a:t>
              </a:r>
              <a:endParaRPr lang="he-IL" sz="170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08B0E008-7125-4B08-8CAC-6A466C057A35}"/>
                </a:ext>
              </a:extLst>
            </p:cNvPr>
            <p:cNvSpPr/>
            <p:nvPr/>
          </p:nvSpPr>
          <p:spPr>
            <a:xfrm>
              <a:off x="4279288" y="467767"/>
              <a:ext cx="3079605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ADC802FA-B3E9-41CA-AD4F-5304EE6ADB10}"/>
                </a:ext>
              </a:extLst>
            </p:cNvPr>
            <p:cNvSpPr/>
            <p:nvPr/>
          </p:nvSpPr>
          <p:spPr>
            <a:xfrm>
              <a:off x="4707630" y="753379"/>
              <a:ext cx="149592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7.5     15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grpSp>
        <p:nvGrpSpPr>
          <p:cNvPr id="92" name="Group 91"/>
          <p:cNvGrpSpPr/>
          <p:nvPr/>
        </p:nvGrpSpPr>
        <p:grpSpPr>
          <a:xfrm>
            <a:off x="-5340" y="3607307"/>
            <a:ext cx="3070474" cy="2952688"/>
            <a:chOff x="-107868" y="3635737"/>
            <a:chExt cx="3070474" cy="2952688"/>
          </a:xfrm>
        </p:grpSpPr>
        <p:grpSp>
          <p:nvGrpSpPr>
            <p:cNvPr id="49" name="Group 48"/>
            <p:cNvGrpSpPr/>
            <p:nvPr/>
          </p:nvGrpSpPr>
          <p:grpSpPr>
            <a:xfrm>
              <a:off x="-107868" y="4118041"/>
              <a:ext cx="2362302" cy="2470384"/>
              <a:chOff x="730872" y="4545626"/>
              <a:chExt cx="2643584" cy="2764536"/>
            </a:xfrm>
          </p:grpSpPr>
          <p:pic>
            <p:nvPicPr>
              <p:cNvPr id="46" name="Picture 45">
                <a:extLst>
                  <a:ext uri="{FF2B5EF4-FFF2-40B4-BE49-F238E27FC236}">
                    <a16:creationId xmlns:a16="http://schemas.microsoft.com/office/drawing/2014/main" id="{A3EFB8E2-609D-461B-B0E4-3F06605007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226" t="20326" r="45788" b="29337"/>
              <a:stretch/>
            </p:blipFill>
            <p:spPr>
              <a:xfrm>
                <a:off x="1543866" y="4545626"/>
                <a:ext cx="1068348" cy="2764536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1E2AB492-87FF-43D0-890C-A5F05AC949C4}"/>
                  </a:ext>
                </a:extLst>
              </p:cNvPr>
              <p:cNvSpPr/>
              <p:nvPr/>
            </p:nvSpPr>
            <p:spPr>
              <a:xfrm>
                <a:off x="730872" y="6430259"/>
                <a:ext cx="838783" cy="39644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89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cl-2</a:t>
                </a:r>
                <a:r>
                  <a:rPr lang="en-US" sz="170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  <a:endParaRPr lang="he-IL" sz="170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A667D837-8909-47CA-A746-EB6C29813EDF}"/>
                  </a:ext>
                </a:extLst>
              </p:cNvPr>
              <p:cNvSpPr/>
              <p:nvPr/>
            </p:nvSpPr>
            <p:spPr>
              <a:xfrm>
                <a:off x="2612213" y="6466013"/>
                <a:ext cx="762243" cy="35426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70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   </a:t>
                </a:r>
                <a:endParaRPr lang="he-IL" sz="170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08B0E008-7125-4B08-8CAC-6A466C057A35}"/>
                </a:ext>
              </a:extLst>
            </p:cNvPr>
            <p:cNvSpPr/>
            <p:nvPr/>
          </p:nvSpPr>
          <p:spPr>
            <a:xfrm>
              <a:off x="210677" y="3635737"/>
              <a:ext cx="2751929" cy="2750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ADC802FA-B3E9-41CA-AD4F-5304EE6ADB10}"/>
                </a:ext>
              </a:extLst>
            </p:cNvPr>
            <p:cNvSpPr/>
            <p:nvPr/>
          </p:nvSpPr>
          <p:spPr>
            <a:xfrm>
              <a:off x="649611" y="3870515"/>
              <a:ext cx="1336753" cy="2475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7.5     15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grpSp>
        <p:nvGrpSpPr>
          <p:cNvPr id="57" name="Group 56"/>
          <p:cNvGrpSpPr/>
          <p:nvPr/>
        </p:nvGrpSpPr>
        <p:grpSpPr>
          <a:xfrm>
            <a:off x="2169145" y="3652034"/>
            <a:ext cx="3067135" cy="2934935"/>
            <a:chOff x="1789199" y="4115778"/>
            <a:chExt cx="3432343" cy="3284402"/>
          </a:xfrm>
        </p:grpSpPr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123E3B6D-E7A5-4DFF-A563-235B48071C30}"/>
                </a:ext>
              </a:extLst>
            </p:cNvPr>
            <p:cNvSpPr/>
            <p:nvPr/>
          </p:nvSpPr>
          <p:spPr>
            <a:xfrm>
              <a:off x="1789199" y="6514424"/>
              <a:ext cx="950118" cy="3964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l-xL</a:t>
              </a:r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endParaRPr lang="he-IL" sz="170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A25FF425-064B-4DEB-A392-53B2DF747F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164" t="33644" r="36365" b="24359"/>
            <a:stretch/>
          </p:blipFill>
          <p:spPr>
            <a:xfrm>
              <a:off x="2672108" y="4635644"/>
              <a:ext cx="1062623" cy="276453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F1EAE7C3-2FEB-431B-8AD9-B10622BE3FCD}"/>
                </a:ext>
              </a:extLst>
            </p:cNvPr>
            <p:cNvSpPr/>
            <p:nvPr/>
          </p:nvSpPr>
          <p:spPr>
            <a:xfrm>
              <a:off x="3726748" y="6391654"/>
              <a:ext cx="613159" cy="3542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9   </a:t>
              </a:r>
              <a:endParaRPr lang="he-IL" sz="170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08B0E008-7125-4B08-8CAC-6A466C057A35}"/>
                </a:ext>
              </a:extLst>
            </p:cNvPr>
            <p:cNvSpPr/>
            <p:nvPr/>
          </p:nvSpPr>
          <p:spPr>
            <a:xfrm>
              <a:off x="2141937" y="4115778"/>
              <a:ext cx="3079605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ADC802FA-B3E9-41CA-AD4F-5304EE6ADB10}"/>
                </a:ext>
              </a:extLst>
            </p:cNvPr>
            <p:cNvSpPr/>
            <p:nvPr/>
          </p:nvSpPr>
          <p:spPr>
            <a:xfrm>
              <a:off x="2633135" y="4378511"/>
              <a:ext cx="149592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7.5     15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grpSp>
        <p:nvGrpSpPr>
          <p:cNvPr id="91" name="Group 90"/>
          <p:cNvGrpSpPr/>
          <p:nvPr/>
        </p:nvGrpSpPr>
        <p:grpSpPr>
          <a:xfrm>
            <a:off x="4109507" y="3653573"/>
            <a:ext cx="3306588" cy="2937171"/>
            <a:chOff x="3377335" y="3651253"/>
            <a:chExt cx="3306588" cy="2937171"/>
          </a:xfrm>
        </p:grpSpPr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55F1CE49-B072-4A26-8E14-8F05FDF43A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76" t="15993" r="63629" b="44469"/>
            <a:stretch/>
          </p:blipFill>
          <p:spPr>
            <a:xfrm>
              <a:off x="4281488" y="4113811"/>
              <a:ext cx="1224314" cy="247461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DED8BBDE-211F-4008-9498-DBB59E017C8F}"/>
                </a:ext>
              </a:extLst>
            </p:cNvPr>
            <p:cNvSpPr/>
            <p:nvPr/>
          </p:nvSpPr>
          <p:spPr>
            <a:xfrm>
              <a:off x="5505803" y="5511171"/>
              <a:ext cx="602667" cy="31656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2   </a:t>
              </a:r>
              <a:endParaRPr lang="he-IL" sz="170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45F2AC62-6B9E-4C45-8873-10BFF5038965}"/>
                </a:ext>
              </a:extLst>
            </p:cNvPr>
            <p:cNvSpPr/>
            <p:nvPr/>
          </p:nvSpPr>
          <p:spPr>
            <a:xfrm>
              <a:off x="3377335" y="5391782"/>
              <a:ext cx="965611" cy="28729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l-GR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  </a:t>
              </a:r>
              <a:endParaRPr lang="he-IL" sz="148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08B0E008-7125-4B08-8CAC-6A466C057A35}"/>
                </a:ext>
              </a:extLst>
            </p:cNvPr>
            <p:cNvSpPr/>
            <p:nvPr/>
          </p:nvSpPr>
          <p:spPr>
            <a:xfrm>
              <a:off x="3931994" y="3651253"/>
              <a:ext cx="2751929" cy="2750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ADC802FA-B3E9-41CA-AD4F-5304EE6ADB10}"/>
                </a:ext>
              </a:extLst>
            </p:cNvPr>
            <p:cNvSpPr/>
            <p:nvPr/>
          </p:nvSpPr>
          <p:spPr>
            <a:xfrm>
              <a:off x="4370928" y="3860631"/>
              <a:ext cx="1336753" cy="2475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7.5     15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grpSp>
        <p:nvGrpSpPr>
          <p:cNvPr id="83" name="Group 82"/>
          <p:cNvGrpSpPr/>
          <p:nvPr/>
        </p:nvGrpSpPr>
        <p:grpSpPr>
          <a:xfrm>
            <a:off x="-16892" y="6911018"/>
            <a:ext cx="3082026" cy="2950695"/>
            <a:chOff x="6129396" y="4082497"/>
            <a:chExt cx="3449007" cy="3302038"/>
          </a:xfrm>
        </p:grpSpPr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1780012C-F629-48F8-850E-1819ACB96D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305" t="17368" r="44108" b="21577"/>
            <a:stretch/>
          </p:blipFill>
          <p:spPr>
            <a:xfrm>
              <a:off x="6967547" y="4600133"/>
              <a:ext cx="1185001" cy="2784402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F555C4B0-D505-4A6C-AAB3-30614FB6C718}"/>
                </a:ext>
              </a:extLst>
            </p:cNvPr>
            <p:cNvSpPr/>
            <p:nvPr/>
          </p:nvSpPr>
          <p:spPr>
            <a:xfrm>
              <a:off x="8152548" y="5814382"/>
              <a:ext cx="742772" cy="3964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    </a:t>
              </a:r>
              <a:endParaRPr lang="he-IL" sz="170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1CC15439-C9F2-4B18-8553-AA16332AEEB2}"/>
                </a:ext>
              </a:extLst>
            </p:cNvPr>
            <p:cNvSpPr/>
            <p:nvPr/>
          </p:nvSpPr>
          <p:spPr>
            <a:xfrm>
              <a:off x="8131650" y="6081726"/>
              <a:ext cx="859050" cy="3964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    </a:t>
              </a:r>
              <a:endParaRPr lang="he-IL" sz="170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08B0E008-7125-4B08-8CAC-6A466C057A35}"/>
                </a:ext>
              </a:extLst>
            </p:cNvPr>
            <p:cNvSpPr/>
            <p:nvPr/>
          </p:nvSpPr>
          <p:spPr>
            <a:xfrm>
              <a:off x="6498798" y="4082497"/>
              <a:ext cx="3079605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ADC802FA-B3E9-41CA-AD4F-5304EE6ADB10}"/>
                </a:ext>
              </a:extLst>
            </p:cNvPr>
            <p:cNvSpPr/>
            <p:nvPr/>
          </p:nvSpPr>
          <p:spPr>
            <a:xfrm>
              <a:off x="6989996" y="4345230"/>
              <a:ext cx="149592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7.5     15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481F3B4D-EC83-4434-BBC0-C1E8E7DB759C}"/>
                </a:ext>
              </a:extLst>
            </p:cNvPr>
            <p:cNvSpPr/>
            <p:nvPr/>
          </p:nvSpPr>
          <p:spPr>
            <a:xfrm>
              <a:off x="6224774" y="5846292"/>
              <a:ext cx="787114" cy="321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C3-I  </a:t>
              </a:r>
              <a:endParaRPr lang="he-IL" sz="148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1555B93F-5BB5-4DFF-A6FA-61CCBCC766FF}"/>
                </a:ext>
              </a:extLst>
            </p:cNvPr>
            <p:cNvSpPr/>
            <p:nvPr/>
          </p:nvSpPr>
          <p:spPr>
            <a:xfrm>
              <a:off x="6129396" y="6101189"/>
              <a:ext cx="894433" cy="35977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C3-II  </a:t>
              </a:r>
              <a:endParaRPr lang="he-IL" sz="148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9" name="Group 88"/>
          <p:cNvGrpSpPr/>
          <p:nvPr/>
        </p:nvGrpSpPr>
        <p:grpSpPr>
          <a:xfrm>
            <a:off x="2258640" y="6968860"/>
            <a:ext cx="3110928" cy="2905759"/>
            <a:chOff x="2057068" y="7781079"/>
            <a:chExt cx="3481350" cy="3251752"/>
          </a:xfrm>
        </p:grpSpPr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7852D86B-586A-4DA4-92D5-69EE7515BA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886" t="23407" r="41235" b="16222"/>
            <a:stretch/>
          </p:blipFill>
          <p:spPr>
            <a:xfrm>
              <a:off x="2960680" y="8293404"/>
              <a:ext cx="942619" cy="2739427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08B0E008-7125-4B08-8CAC-6A466C057A35}"/>
                </a:ext>
              </a:extLst>
            </p:cNvPr>
            <p:cNvSpPr/>
            <p:nvPr/>
          </p:nvSpPr>
          <p:spPr>
            <a:xfrm>
              <a:off x="2458813" y="7781079"/>
              <a:ext cx="3079605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ADC802FA-B3E9-41CA-AD4F-5304EE6ADB10}"/>
                </a:ext>
              </a:extLst>
            </p:cNvPr>
            <p:cNvSpPr/>
            <p:nvPr/>
          </p:nvSpPr>
          <p:spPr>
            <a:xfrm>
              <a:off x="2950011" y="8043812"/>
              <a:ext cx="149592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7.5     15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8BAB4277-3BA4-4084-B353-806A442BDC3A}"/>
                </a:ext>
              </a:extLst>
            </p:cNvPr>
            <p:cNvSpPr/>
            <p:nvPr/>
          </p:nvSpPr>
          <p:spPr>
            <a:xfrm>
              <a:off x="2057068" y="8587556"/>
              <a:ext cx="898277" cy="321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l-GR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  </a:t>
              </a:r>
              <a:endParaRPr lang="he-IL" sz="148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D71B0D75-29B0-4229-A45D-29129FB7772A}"/>
                </a:ext>
              </a:extLst>
            </p:cNvPr>
            <p:cNvSpPr/>
            <p:nvPr/>
          </p:nvSpPr>
          <p:spPr>
            <a:xfrm>
              <a:off x="3895726" y="8592284"/>
              <a:ext cx="461011" cy="3542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2   </a:t>
              </a:r>
              <a:endParaRPr lang="he-IL" sz="170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3" name="TextBox 92">
            <a:extLst>
              <a:ext uri="{FF2B5EF4-FFF2-40B4-BE49-F238E27FC236}">
                <a16:creationId xmlns:a16="http://schemas.microsoft.com/office/drawing/2014/main" id="{4D1134CB-6E36-4CE8-A889-E6214D75CDF7}"/>
              </a:ext>
            </a:extLst>
          </p:cNvPr>
          <p:cNvSpPr txBox="1"/>
          <p:nvPr/>
        </p:nvSpPr>
        <p:spPr>
          <a:xfrm>
            <a:off x="-25010" y="6542907"/>
            <a:ext cx="2341977" cy="41966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27" b="1" dirty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utophagy</a:t>
            </a:r>
            <a:endParaRPr lang="he-IL" sz="2127" b="1" dirty="0">
              <a:solidFill>
                <a:srgbClr val="3333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1545408" y="3011533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. A</a:t>
            </a: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3420171" y="3019380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. A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5478024" y="3034871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. A</a:t>
            </a: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1072116" y="6314604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. A</a:t>
            </a: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3312294" y="6323313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. A</a:t>
            </a: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5657605" y="6318397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. A</a:t>
            </a: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1177345" y="9588115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. C</a:t>
            </a: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3312294" y="9588115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2. C</a:t>
            </a:r>
          </a:p>
        </p:txBody>
      </p:sp>
    </p:spTree>
    <p:extLst>
      <p:ext uri="{BB962C8B-B14F-4D97-AF65-F5344CB8AC3E}">
        <p14:creationId xmlns:p14="http://schemas.microsoft.com/office/powerpoint/2010/main" val="5753094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E6787829-298A-4293-A0F9-BEDF54286188}"/>
              </a:ext>
            </a:extLst>
          </p:cNvPr>
          <p:cNvSpPr txBox="1"/>
          <p:nvPr/>
        </p:nvSpPr>
        <p:spPr>
          <a:xfrm>
            <a:off x="0" y="109558"/>
            <a:ext cx="2152962" cy="41966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27" b="1" dirty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abolism </a:t>
            </a:r>
            <a:endParaRPr lang="he-IL" sz="2127" b="1" dirty="0">
              <a:solidFill>
                <a:srgbClr val="3333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8" name="Group 87"/>
          <p:cNvGrpSpPr/>
          <p:nvPr/>
        </p:nvGrpSpPr>
        <p:grpSpPr>
          <a:xfrm>
            <a:off x="-421988" y="586670"/>
            <a:ext cx="3585623" cy="2783211"/>
            <a:chOff x="-378691" y="730138"/>
            <a:chExt cx="3983051" cy="3091700"/>
          </a:xfrm>
        </p:grpSpPr>
        <p:pic>
          <p:nvPicPr>
            <p:cNvPr id="79" name="Picture 78">
              <a:extLst>
                <a:ext uri="{FF2B5EF4-FFF2-40B4-BE49-F238E27FC236}">
                  <a16:creationId xmlns:a16="http://schemas.microsoft.com/office/drawing/2014/main" id="{D4C2EA51-5BDB-4DA1-9B54-A5584A13D1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40" t="8860" r="45351" b="32468"/>
            <a:stretch/>
          </p:blipFill>
          <p:spPr>
            <a:xfrm>
              <a:off x="777691" y="1255965"/>
              <a:ext cx="1465073" cy="256587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BC85EE8E-277A-47EA-88AE-699BF015FCF9}"/>
                </a:ext>
              </a:extLst>
            </p:cNvPr>
            <p:cNvSpPr/>
            <p:nvPr/>
          </p:nvSpPr>
          <p:spPr>
            <a:xfrm>
              <a:off x="-378691" y="3301092"/>
              <a:ext cx="1174704" cy="34189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DAC1  </a:t>
              </a:r>
              <a:endParaRPr lang="he-IL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2A529090-E12F-4821-8C7C-8DAD17151B20}"/>
                </a:ext>
              </a:extLst>
            </p:cNvPr>
            <p:cNvSpPr/>
            <p:nvPr/>
          </p:nvSpPr>
          <p:spPr>
            <a:xfrm>
              <a:off x="2211874" y="3331870"/>
              <a:ext cx="744894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1   </a:t>
              </a:r>
              <a:endParaRPr lang="he-IL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9ABAE885-CDC2-4ED8-BB92-2AFC89096EC3}"/>
                </a:ext>
              </a:extLst>
            </p:cNvPr>
            <p:cNvSpPr/>
            <p:nvPr/>
          </p:nvSpPr>
          <p:spPr>
            <a:xfrm>
              <a:off x="554658" y="730138"/>
              <a:ext cx="304970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7501C4F3-ACEC-488B-84BD-1DAB413FEA94}"/>
                </a:ext>
              </a:extLst>
            </p:cNvPr>
            <p:cNvSpPr/>
            <p:nvPr/>
          </p:nvSpPr>
          <p:spPr>
            <a:xfrm>
              <a:off x="923882" y="1001657"/>
              <a:ext cx="17267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 7.5        15 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grpSp>
        <p:nvGrpSpPr>
          <p:cNvPr id="89" name="Group 88"/>
          <p:cNvGrpSpPr/>
          <p:nvPr/>
        </p:nvGrpSpPr>
        <p:grpSpPr>
          <a:xfrm>
            <a:off x="2119873" y="607977"/>
            <a:ext cx="3103686" cy="2769032"/>
            <a:chOff x="2791630" y="739700"/>
            <a:chExt cx="3447697" cy="3075949"/>
          </a:xfrm>
        </p:grpSpPr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3650A692-24FF-4BB4-A0FC-CBB8E6E06B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098" t="15368" r="32086" b="7083"/>
            <a:stretch/>
          </p:blipFill>
          <p:spPr>
            <a:xfrm>
              <a:off x="3410692" y="1269317"/>
              <a:ext cx="1155700" cy="2546332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1F1E6057-8827-4248-A226-F926517BC766}"/>
                </a:ext>
              </a:extLst>
            </p:cNvPr>
            <p:cNvSpPr/>
            <p:nvPr/>
          </p:nvSpPr>
          <p:spPr>
            <a:xfrm>
              <a:off x="2791630" y="1453237"/>
              <a:ext cx="65911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K-I  </a:t>
              </a:r>
              <a:endParaRPr lang="he-IL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2A529090-E12F-4821-8C7C-8DAD17151B20}"/>
                </a:ext>
              </a:extLst>
            </p:cNvPr>
            <p:cNvSpPr/>
            <p:nvPr/>
          </p:nvSpPr>
          <p:spPr>
            <a:xfrm>
              <a:off x="4506059" y="1881386"/>
              <a:ext cx="744894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 </a:t>
              </a:r>
              <a:endParaRPr lang="he-IL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9ABAE885-CDC2-4ED8-BB92-2AFC89096EC3}"/>
                </a:ext>
              </a:extLst>
            </p:cNvPr>
            <p:cNvSpPr/>
            <p:nvPr/>
          </p:nvSpPr>
          <p:spPr>
            <a:xfrm>
              <a:off x="3189625" y="739700"/>
              <a:ext cx="304970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7501C4F3-ACEC-488B-84BD-1DAB413FEA94}"/>
                </a:ext>
              </a:extLst>
            </p:cNvPr>
            <p:cNvSpPr/>
            <p:nvPr/>
          </p:nvSpPr>
          <p:spPr>
            <a:xfrm>
              <a:off x="3471042" y="1004236"/>
              <a:ext cx="149592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7.5    15  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grpSp>
        <p:nvGrpSpPr>
          <p:cNvPr id="101" name="Group 100"/>
          <p:cNvGrpSpPr/>
          <p:nvPr/>
        </p:nvGrpSpPr>
        <p:grpSpPr>
          <a:xfrm>
            <a:off x="3875004" y="574288"/>
            <a:ext cx="3638665" cy="2804284"/>
            <a:chOff x="3443666" y="680506"/>
            <a:chExt cx="4041972" cy="3115109"/>
          </a:xfrm>
        </p:grpSpPr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ADCF8785-AD6B-4E82-A814-AEFF346BBD31}"/>
                </a:ext>
              </a:extLst>
            </p:cNvPr>
            <p:cNvSpPr/>
            <p:nvPr/>
          </p:nvSpPr>
          <p:spPr>
            <a:xfrm>
              <a:off x="3443666" y="1918613"/>
              <a:ext cx="1211343" cy="321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PSyn5a</a:t>
              </a:r>
              <a:endParaRPr lang="he-IL" sz="148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AE1C3F32-2C9E-4D56-A652-609F6C4ECAA0}"/>
                </a:ext>
              </a:extLst>
            </p:cNvPr>
            <p:cNvSpPr/>
            <p:nvPr/>
          </p:nvSpPr>
          <p:spPr>
            <a:xfrm>
              <a:off x="5868319" y="1844059"/>
              <a:ext cx="839191" cy="3542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8   </a:t>
              </a:r>
              <a:endParaRPr lang="he-IL" sz="170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0" name="Picture 89">
              <a:extLst>
                <a:ext uri="{FF2B5EF4-FFF2-40B4-BE49-F238E27FC236}">
                  <a16:creationId xmlns:a16="http://schemas.microsoft.com/office/drawing/2014/main" id="{4551E314-AE9A-4772-8A4F-30FFE2160D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521" t="31998" r="46174" b="22570"/>
            <a:stretch/>
          </p:blipFill>
          <p:spPr>
            <a:xfrm>
              <a:off x="4595957" y="1210122"/>
              <a:ext cx="1272362" cy="258549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9ABAE885-CDC2-4ED8-BB92-2AFC89096EC3}"/>
                </a:ext>
              </a:extLst>
            </p:cNvPr>
            <p:cNvSpPr/>
            <p:nvPr/>
          </p:nvSpPr>
          <p:spPr>
            <a:xfrm>
              <a:off x="4435936" y="680506"/>
              <a:ext cx="304970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7501C4F3-ACEC-488B-84BD-1DAB413FEA94}"/>
                </a:ext>
              </a:extLst>
            </p:cNvPr>
            <p:cNvSpPr/>
            <p:nvPr/>
          </p:nvSpPr>
          <p:spPr>
            <a:xfrm>
              <a:off x="4735012" y="945042"/>
              <a:ext cx="168828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7.5        15  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grpSp>
        <p:nvGrpSpPr>
          <p:cNvPr id="102" name="Group 101"/>
          <p:cNvGrpSpPr/>
          <p:nvPr/>
        </p:nvGrpSpPr>
        <p:grpSpPr>
          <a:xfrm>
            <a:off x="-774254" y="3864913"/>
            <a:ext cx="3701469" cy="2762633"/>
            <a:chOff x="-1069557" y="4252885"/>
            <a:chExt cx="4111737" cy="3068841"/>
          </a:xfrm>
        </p:grpSpPr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0F5DD750-003D-45E6-A6E6-EAE93A12D7B2}"/>
                </a:ext>
              </a:extLst>
            </p:cNvPr>
            <p:cNvSpPr/>
            <p:nvPr/>
          </p:nvSpPr>
          <p:spPr>
            <a:xfrm>
              <a:off x="-1069557" y="5762553"/>
              <a:ext cx="1456104" cy="321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he-IL" sz="148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0" name="Group 99"/>
            <p:cNvGrpSpPr/>
            <p:nvPr/>
          </p:nvGrpSpPr>
          <p:grpSpPr>
            <a:xfrm>
              <a:off x="-7522" y="4252885"/>
              <a:ext cx="3049702" cy="3068841"/>
              <a:chOff x="415239" y="4252885"/>
              <a:chExt cx="3049702" cy="3068841"/>
            </a:xfrm>
          </p:grpSpPr>
          <p:pic>
            <p:nvPicPr>
              <p:cNvPr id="93" name="Picture 92">
                <a:extLst>
                  <a:ext uri="{FF2B5EF4-FFF2-40B4-BE49-F238E27FC236}">
                    <a16:creationId xmlns:a16="http://schemas.microsoft.com/office/drawing/2014/main" id="{BDA76CFF-306C-48CD-8B37-95C53BBC08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779" t="20251" r="54951" b="23535"/>
              <a:stretch/>
            </p:blipFill>
            <p:spPr>
              <a:xfrm>
                <a:off x="784463" y="4785384"/>
                <a:ext cx="1155086" cy="2536342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94" name="Rectangle 93">
                <a:extLst>
                  <a:ext uri="{FF2B5EF4-FFF2-40B4-BE49-F238E27FC236}">
                    <a16:creationId xmlns:a16="http://schemas.microsoft.com/office/drawing/2014/main" id="{9ABAE885-CDC2-4ED8-BB92-2AFC89096EC3}"/>
                  </a:ext>
                </a:extLst>
              </p:cNvPr>
              <p:cNvSpPr/>
              <p:nvPr/>
            </p:nvSpPr>
            <p:spPr>
              <a:xfrm>
                <a:off x="415239" y="4252885"/>
                <a:ext cx="3049702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>
                    <a:solidFill>
                      <a:sysClr val="windowText" lastClr="000000"/>
                    </a:solidFill>
                    <a:effectLst>
                      <a:outerShdw blurRad="38100" dist="38100" dir="2700000" algn="tl" rotWithShape="0">
                        <a:srgbClr val="C0C0C0"/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-</a:t>
                </a:r>
                <a:r>
                  <a:rPr lang="el-GR" sz="1400" b="1" dirty="0">
                    <a:solidFill>
                      <a:sysClr val="windowText" lastClr="000000"/>
                    </a:solidFill>
                    <a:effectLst>
                      <a:outerShdw blurRad="38100" dist="38100" dir="2700000" algn="tl" rotWithShape="0">
                        <a:srgbClr val="C0C0C0"/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Δ</a:t>
                </a:r>
                <a:r>
                  <a:rPr lang="en-US" sz="1400" b="1" dirty="0">
                    <a:solidFill>
                      <a:sysClr val="windowText" lastClr="000000"/>
                    </a:solidFill>
                    <a:effectLst>
                      <a:outerShdw blurRad="38100" dist="38100" dir="2700000" algn="tl" rotWithShape="0">
                        <a:srgbClr val="C0C0C0"/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1-18)N-Ter-Antp, </a:t>
                </a:r>
                <a:r>
                  <a:rPr lang="en-US" sz="1400" b="1" dirty="0">
                    <a:latin typeface="Symbol" panose="05050102010706020507" pitchFamily="18" charset="2"/>
                    <a:cs typeface="Times New Roman" panose="02020603050405020304" pitchFamily="18" charset="0"/>
                  </a:rPr>
                  <a:t>m</a:t>
                </a:r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</a:p>
            </p:txBody>
          </p:sp>
          <p:sp>
            <p:nvSpPr>
              <p:cNvPr id="95" name="Rectangle 94">
                <a:extLst>
                  <a:ext uri="{FF2B5EF4-FFF2-40B4-BE49-F238E27FC236}">
                    <a16:creationId xmlns:a16="http://schemas.microsoft.com/office/drawing/2014/main" id="{7501C4F3-ACEC-488B-84BD-1DAB413FEA94}"/>
                  </a:ext>
                </a:extLst>
              </p:cNvPr>
              <p:cNvSpPr/>
              <p:nvPr/>
            </p:nvSpPr>
            <p:spPr>
              <a:xfrm>
                <a:off x="784463" y="4524404"/>
                <a:ext cx="172675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        7.5        15     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he-IL" sz="1200" dirty="0"/>
              </a:p>
            </p:txBody>
          </p:sp>
          <p:sp>
            <p:nvSpPr>
              <p:cNvPr id="96" name="Rectangle 95">
                <a:extLst>
                  <a:ext uri="{FF2B5EF4-FFF2-40B4-BE49-F238E27FC236}">
                    <a16:creationId xmlns:a16="http://schemas.microsoft.com/office/drawing/2014/main" id="{23AFA316-C11D-416E-B1DC-2B0E7BB4E701}"/>
                  </a:ext>
                </a:extLst>
              </p:cNvPr>
              <p:cNvSpPr/>
              <p:nvPr/>
            </p:nvSpPr>
            <p:spPr>
              <a:xfrm>
                <a:off x="1913561" y="5686305"/>
                <a:ext cx="834208" cy="35426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702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3  </a:t>
                </a:r>
                <a:endParaRPr lang="he-IL" sz="1702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99" name="Group 98"/>
          <p:cNvGrpSpPr/>
          <p:nvPr/>
        </p:nvGrpSpPr>
        <p:grpSpPr>
          <a:xfrm>
            <a:off x="1805477" y="3820659"/>
            <a:ext cx="3352410" cy="2795133"/>
            <a:chOff x="1979663" y="4266135"/>
            <a:chExt cx="3723989" cy="3104943"/>
          </a:xfrm>
        </p:grpSpPr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F5566790-BE30-43DB-B644-6C42A00514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195" t="15703" r="44722" b="18064"/>
            <a:stretch/>
          </p:blipFill>
          <p:spPr>
            <a:xfrm>
              <a:off x="3000433" y="4793984"/>
              <a:ext cx="1216971" cy="2577094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B9E83F95-7CCD-43F1-8DE6-7B65615C9F86}"/>
                </a:ext>
              </a:extLst>
            </p:cNvPr>
            <p:cNvSpPr/>
            <p:nvPr/>
          </p:nvSpPr>
          <p:spPr>
            <a:xfrm>
              <a:off x="1979663" y="5816598"/>
              <a:ext cx="1055062" cy="321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l-GR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  </a:t>
              </a:r>
              <a:endParaRPr lang="he-IL" sz="148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B3845569-3870-4CCE-A98A-937CE1035748}"/>
                </a:ext>
              </a:extLst>
            </p:cNvPr>
            <p:cNvSpPr/>
            <p:nvPr/>
          </p:nvSpPr>
          <p:spPr>
            <a:xfrm>
              <a:off x="4178801" y="5681995"/>
              <a:ext cx="584270" cy="3542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7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2   </a:t>
              </a:r>
              <a:endParaRPr lang="he-IL" sz="170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9ABAE885-CDC2-4ED8-BB92-2AFC89096EC3}"/>
                </a:ext>
              </a:extLst>
            </p:cNvPr>
            <p:cNvSpPr/>
            <p:nvPr/>
          </p:nvSpPr>
          <p:spPr>
            <a:xfrm>
              <a:off x="2653950" y="4266135"/>
              <a:ext cx="304970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7501C4F3-ACEC-488B-84BD-1DAB413FEA94}"/>
                </a:ext>
              </a:extLst>
            </p:cNvPr>
            <p:cNvSpPr/>
            <p:nvPr/>
          </p:nvSpPr>
          <p:spPr>
            <a:xfrm>
              <a:off x="3023174" y="4537654"/>
              <a:ext cx="16498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7.5      15 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sp>
        <p:nvSpPr>
          <p:cNvPr id="104" name="Rectangle 103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1377068" y="3208872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A</a:t>
            </a:r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3151197" y="3154568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A</a:t>
            </a: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5459658" y="3098034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A</a:t>
            </a:r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3272166" y="6306048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A</a:t>
            </a: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998443" y="6407807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A</a:t>
            </a:r>
          </a:p>
        </p:txBody>
      </p:sp>
    </p:spTree>
    <p:extLst>
      <p:ext uri="{BB962C8B-B14F-4D97-AF65-F5344CB8AC3E}">
        <p14:creationId xmlns:p14="http://schemas.microsoft.com/office/powerpoint/2010/main" val="20901868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4392B0E-DA56-4351-BCE4-D527C010571A}"/>
              </a:ext>
            </a:extLst>
          </p:cNvPr>
          <p:cNvSpPr txBox="1"/>
          <p:nvPr/>
        </p:nvSpPr>
        <p:spPr>
          <a:xfrm>
            <a:off x="92197" y="0"/>
            <a:ext cx="2452082" cy="41966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127" b="1" dirty="0" err="1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gnalling</a:t>
            </a:r>
            <a:r>
              <a:rPr lang="en-US" sz="2127" b="1" dirty="0">
                <a:solidFill>
                  <a:srgbClr val="33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he-IL" sz="2127" b="1" dirty="0">
              <a:solidFill>
                <a:srgbClr val="3333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6" name="Group 55"/>
          <p:cNvGrpSpPr/>
          <p:nvPr/>
        </p:nvGrpSpPr>
        <p:grpSpPr>
          <a:xfrm>
            <a:off x="-126973" y="507952"/>
            <a:ext cx="2918041" cy="2752246"/>
            <a:chOff x="-276053" y="503132"/>
            <a:chExt cx="3526207" cy="3325857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2EA49D85-B931-4C80-A67D-9D7901CAB3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246" t="20956" r="58070" b="36029"/>
            <a:stretch/>
          </p:blipFill>
          <p:spPr>
            <a:xfrm>
              <a:off x="445910" y="1051650"/>
              <a:ext cx="1568242" cy="277733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9ABAE885-CDC2-4ED8-BB92-2AFC89096EC3}"/>
                </a:ext>
              </a:extLst>
            </p:cNvPr>
            <p:cNvSpPr/>
            <p:nvPr/>
          </p:nvSpPr>
          <p:spPr>
            <a:xfrm>
              <a:off x="200452" y="503132"/>
              <a:ext cx="304970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7501C4F3-ACEC-488B-84BD-1DAB413FEA94}"/>
                </a:ext>
              </a:extLst>
            </p:cNvPr>
            <p:cNvSpPr/>
            <p:nvPr/>
          </p:nvSpPr>
          <p:spPr>
            <a:xfrm>
              <a:off x="643818" y="774651"/>
              <a:ext cx="17267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 7.5        15 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97E71419-E10F-4290-8EC1-9B37CB10B90E}"/>
                </a:ext>
              </a:extLst>
            </p:cNvPr>
            <p:cNvSpPr/>
            <p:nvPr/>
          </p:nvSpPr>
          <p:spPr>
            <a:xfrm>
              <a:off x="2014152" y="2295984"/>
              <a:ext cx="61470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   </a:t>
              </a:r>
              <a:endParaRPr lang="he-IL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4C40CFED-2782-4952-B87D-A459AC4306EB}"/>
                </a:ext>
              </a:extLst>
            </p:cNvPr>
            <p:cNvSpPr/>
            <p:nvPr/>
          </p:nvSpPr>
          <p:spPr>
            <a:xfrm>
              <a:off x="-276053" y="2244691"/>
              <a:ext cx="768348" cy="321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-Jun  </a:t>
              </a:r>
              <a:endParaRPr lang="he-IL" sz="148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-555671" y="3574421"/>
            <a:ext cx="3676570" cy="2793331"/>
            <a:chOff x="-1078155" y="4042608"/>
            <a:chExt cx="4442825" cy="3375506"/>
          </a:xfrm>
        </p:grpSpPr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24152FB5-61CF-4CA4-A480-89ED7711E68E}"/>
                </a:ext>
              </a:extLst>
            </p:cNvPr>
            <p:cNvSpPr/>
            <p:nvPr/>
          </p:nvSpPr>
          <p:spPr>
            <a:xfrm>
              <a:off x="-1078155" y="5731557"/>
              <a:ext cx="1545511" cy="3885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l-GR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  </a:t>
              </a:r>
              <a:endParaRPr lang="he-IL" sz="148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1ABD73A7-17A4-42E8-A750-3400EE5126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684" t="6200" r="40176" b="34580"/>
            <a:stretch/>
          </p:blipFill>
          <p:spPr>
            <a:xfrm>
              <a:off x="455436" y="4637845"/>
              <a:ext cx="1403124" cy="278026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492C73CA-4A45-481F-BA47-9046F40F2AF4}"/>
                </a:ext>
              </a:extLst>
            </p:cNvPr>
            <p:cNvSpPr/>
            <p:nvPr/>
          </p:nvSpPr>
          <p:spPr>
            <a:xfrm>
              <a:off x="1814993" y="5786727"/>
              <a:ext cx="433978" cy="28866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7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2   </a:t>
              </a:r>
              <a:endParaRPr lang="he-IL" sz="127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9ABAE885-CDC2-4ED8-BB92-2AFC89096EC3}"/>
                </a:ext>
              </a:extLst>
            </p:cNvPr>
            <p:cNvSpPr/>
            <p:nvPr/>
          </p:nvSpPr>
          <p:spPr>
            <a:xfrm>
              <a:off x="314968" y="4042608"/>
              <a:ext cx="304970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7501C4F3-ACEC-488B-84BD-1DAB413FEA94}"/>
                </a:ext>
              </a:extLst>
            </p:cNvPr>
            <p:cNvSpPr/>
            <p:nvPr/>
          </p:nvSpPr>
          <p:spPr>
            <a:xfrm>
              <a:off x="454860" y="4348486"/>
              <a:ext cx="17267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 7.5        15 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1910052" y="486420"/>
            <a:ext cx="3142953" cy="2797541"/>
            <a:chOff x="1685258" y="454365"/>
            <a:chExt cx="3797994" cy="3380592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B931E42C-AB54-4B7F-B3DC-42C6A4733E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129" t="19148" r="38110" b="55626"/>
            <a:stretch/>
          </p:blipFill>
          <p:spPr>
            <a:xfrm>
              <a:off x="2568481" y="1029974"/>
              <a:ext cx="1416431" cy="280498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C848D63B-3339-416C-B136-A7D39D669266}"/>
                </a:ext>
              </a:extLst>
            </p:cNvPr>
            <p:cNvSpPr/>
            <p:nvPr/>
          </p:nvSpPr>
          <p:spPr>
            <a:xfrm>
              <a:off x="3996364" y="1758505"/>
              <a:ext cx="656435" cy="28866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7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5   </a:t>
              </a:r>
              <a:endParaRPr lang="he-IL" sz="127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510E9968-18EB-4A7A-B3F9-3C95E6B1DD7F}"/>
                </a:ext>
              </a:extLst>
            </p:cNvPr>
            <p:cNvSpPr/>
            <p:nvPr/>
          </p:nvSpPr>
          <p:spPr>
            <a:xfrm>
              <a:off x="1685258" y="1733521"/>
              <a:ext cx="1790899" cy="6654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F-kB</a:t>
              </a:r>
            </a:p>
            <a:p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p65  </a:t>
              </a:r>
              <a:endParaRPr lang="he-IL" sz="148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9ABAE885-CDC2-4ED8-BB92-2AFC89096EC3}"/>
                </a:ext>
              </a:extLst>
            </p:cNvPr>
            <p:cNvSpPr/>
            <p:nvPr/>
          </p:nvSpPr>
          <p:spPr>
            <a:xfrm>
              <a:off x="2433550" y="454365"/>
              <a:ext cx="304970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7501C4F3-ACEC-488B-84BD-1DAB413FEA94}"/>
                </a:ext>
              </a:extLst>
            </p:cNvPr>
            <p:cNvSpPr/>
            <p:nvPr/>
          </p:nvSpPr>
          <p:spPr>
            <a:xfrm>
              <a:off x="2620625" y="752975"/>
              <a:ext cx="17267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 7.5        15 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grpSp>
        <p:nvGrpSpPr>
          <p:cNvPr id="54" name="Group 53"/>
          <p:cNvGrpSpPr/>
          <p:nvPr/>
        </p:nvGrpSpPr>
        <p:grpSpPr>
          <a:xfrm>
            <a:off x="1836500" y="3578277"/>
            <a:ext cx="3442300" cy="2818161"/>
            <a:chOff x="1273783" y="4047605"/>
            <a:chExt cx="4159730" cy="3405509"/>
          </a:xfrm>
        </p:grpSpPr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4E390FDF-E389-4481-A647-F2C1BBF403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440" t="22173" r="35350" b="38852"/>
            <a:stretch/>
          </p:blipFill>
          <p:spPr>
            <a:xfrm>
              <a:off x="2523703" y="4598703"/>
              <a:ext cx="1310419" cy="2854411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D047E9F9-A382-4DD4-9FD7-51066CC1AD5D}"/>
                </a:ext>
              </a:extLst>
            </p:cNvPr>
            <p:cNvSpPr/>
            <p:nvPr/>
          </p:nvSpPr>
          <p:spPr>
            <a:xfrm>
              <a:off x="1273783" y="5786726"/>
              <a:ext cx="1268317" cy="3885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l-GR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</a:t>
              </a:r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  </a:t>
              </a:r>
              <a:endParaRPr lang="he-IL" sz="148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E1BD9F72-393C-4987-84C5-A2CC59E82944}"/>
                </a:ext>
              </a:extLst>
            </p:cNvPr>
            <p:cNvSpPr/>
            <p:nvPr/>
          </p:nvSpPr>
          <p:spPr>
            <a:xfrm>
              <a:off x="3863872" y="5786726"/>
              <a:ext cx="703300" cy="28866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7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2   </a:t>
              </a:r>
              <a:endParaRPr lang="he-IL" sz="127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9ABAE885-CDC2-4ED8-BB92-2AFC89096EC3}"/>
                </a:ext>
              </a:extLst>
            </p:cNvPr>
            <p:cNvSpPr/>
            <p:nvPr/>
          </p:nvSpPr>
          <p:spPr>
            <a:xfrm>
              <a:off x="2383811" y="4047605"/>
              <a:ext cx="304970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7501C4F3-ACEC-488B-84BD-1DAB413FEA94}"/>
                </a:ext>
              </a:extLst>
            </p:cNvPr>
            <p:cNvSpPr/>
            <p:nvPr/>
          </p:nvSpPr>
          <p:spPr>
            <a:xfrm>
              <a:off x="2523703" y="4297608"/>
              <a:ext cx="17267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 7.5        15 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grpSp>
        <p:nvGrpSpPr>
          <p:cNvPr id="75" name="Group 74"/>
          <p:cNvGrpSpPr/>
          <p:nvPr/>
        </p:nvGrpSpPr>
        <p:grpSpPr>
          <a:xfrm>
            <a:off x="4660295" y="3593402"/>
            <a:ext cx="2836837" cy="2862464"/>
            <a:chOff x="4179336" y="4066092"/>
            <a:chExt cx="3428079" cy="3459046"/>
          </a:xfrm>
        </p:grpSpPr>
        <p:pic>
          <p:nvPicPr>
            <p:cNvPr id="57" name="Picture 56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236" t="12611" r="19830" b="55506"/>
            <a:stretch/>
          </p:blipFill>
          <p:spPr>
            <a:xfrm>
              <a:off x="4668285" y="4630624"/>
              <a:ext cx="1351746" cy="2894514"/>
            </a:xfrm>
            <a:custGeom>
              <a:avLst/>
              <a:gdLst>
                <a:gd name="connsiteX0" fmla="*/ 0 w 1657350"/>
                <a:gd name="connsiteY0" fmla="*/ 0 h 184665"/>
                <a:gd name="connsiteX1" fmla="*/ 1657350 w 1657350"/>
                <a:gd name="connsiteY1" fmla="*/ 0 h 184665"/>
                <a:gd name="connsiteX2" fmla="*/ 1657350 w 1657350"/>
                <a:gd name="connsiteY2" fmla="*/ 184665 h 184665"/>
                <a:gd name="connsiteX3" fmla="*/ 0 w 1657350"/>
                <a:gd name="connsiteY3" fmla="*/ 184665 h 1846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57350" h="184665">
                  <a:moveTo>
                    <a:pt x="0" y="0"/>
                  </a:moveTo>
                  <a:lnTo>
                    <a:pt x="1657350" y="0"/>
                  </a:lnTo>
                  <a:lnTo>
                    <a:pt x="1657350" y="184665"/>
                  </a:lnTo>
                  <a:lnTo>
                    <a:pt x="0" y="184665"/>
                  </a:lnTo>
                  <a:close/>
                </a:path>
              </a:pathLst>
            </a:custGeom>
            <a:ln w="19050">
              <a:solidFill>
                <a:schemeClr val="tx1"/>
              </a:solidFill>
            </a:ln>
          </p:spPr>
        </p:pic>
        <p:sp>
          <p:nvSpPr>
            <p:cNvPr id="58" name="TextBox 57"/>
            <p:cNvSpPr txBox="1"/>
            <p:nvPr/>
          </p:nvSpPr>
          <p:spPr>
            <a:xfrm>
              <a:off x="6020031" y="5552292"/>
              <a:ext cx="850083" cy="2886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7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4179336" y="5485168"/>
              <a:ext cx="482824" cy="32149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1489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53</a:t>
              </a: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9ABAE885-CDC2-4ED8-BB92-2AFC89096EC3}"/>
                </a:ext>
              </a:extLst>
            </p:cNvPr>
            <p:cNvSpPr/>
            <p:nvPr/>
          </p:nvSpPr>
          <p:spPr>
            <a:xfrm>
              <a:off x="4557713" y="4066092"/>
              <a:ext cx="304970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7501C4F3-ACEC-488B-84BD-1DAB413FEA94}"/>
                </a:ext>
              </a:extLst>
            </p:cNvPr>
            <p:cNvSpPr/>
            <p:nvPr/>
          </p:nvSpPr>
          <p:spPr>
            <a:xfrm>
              <a:off x="4683147" y="4357315"/>
              <a:ext cx="17267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 7.5        15 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</p:grpSp>
      <p:sp>
        <p:nvSpPr>
          <p:cNvPr id="67" name="TextBox 66"/>
          <p:cNvSpPr txBox="1"/>
          <p:nvPr/>
        </p:nvSpPr>
        <p:spPr>
          <a:xfrm flipH="1">
            <a:off x="4127998" y="2312518"/>
            <a:ext cx="583940" cy="2660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2</a:t>
            </a:r>
          </a:p>
        </p:txBody>
      </p:sp>
      <p:grpSp>
        <p:nvGrpSpPr>
          <p:cNvPr id="76" name="Group 75"/>
          <p:cNvGrpSpPr/>
          <p:nvPr/>
        </p:nvGrpSpPr>
        <p:grpSpPr>
          <a:xfrm>
            <a:off x="120900" y="6765838"/>
            <a:ext cx="2999999" cy="2876094"/>
            <a:chOff x="6089448" y="4073991"/>
            <a:chExt cx="3625246" cy="3475517"/>
          </a:xfrm>
        </p:grpSpPr>
        <p:pic>
          <p:nvPicPr>
            <p:cNvPr id="69" name="Picture 68"/>
            <p:cNvPicPr>
              <a:picLocks noChangeAspect="1"/>
            </p:cNvPicPr>
            <p:nvPr/>
          </p:nvPicPr>
          <p:blipFill rotWithShape="1">
            <a:blip r:embed="rId11"/>
            <a:srcRect l="45128" t="24689" r="38163" b="28428"/>
            <a:stretch/>
          </p:blipFill>
          <p:spPr>
            <a:xfrm flipH="1">
              <a:off x="6708718" y="4645239"/>
              <a:ext cx="1298716" cy="290426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70" name="TextBox 69"/>
            <p:cNvSpPr txBox="1"/>
            <p:nvPr/>
          </p:nvSpPr>
          <p:spPr>
            <a:xfrm flipH="1">
              <a:off x="6089448" y="6206198"/>
              <a:ext cx="6351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l-G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κ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-</a:t>
              </a:r>
              <a:r>
                <a:rPr lang="el-G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9ABAE885-CDC2-4ED8-BB92-2AFC89096EC3}"/>
                </a:ext>
              </a:extLst>
            </p:cNvPr>
            <p:cNvSpPr/>
            <p:nvPr/>
          </p:nvSpPr>
          <p:spPr>
            <a:xfrm>
              <a:off x="6664992" y="4073991"/>
              <a:ext cx="304970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7501C4F3-ACEC-488B-84BD-1DAB413FEA94}"/>
                </a:ext>
              </a:extLst>
            </p:cNvPr>
            <p:cNvSpPr/>
            <p:nvPr/>
          </p:nvSpPr>
          <p:spPr>
            <a:xfrm>
              <a:off x="6804884" y="4379869"/>
              <a:ext cx="16498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 7.5      15 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8029653" y="6186605"/>
              <a:ext cx="850083" cy="2886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7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6</a:t>
              </a:r>
            </a:p>
          </p:txBody>
        </p:sp>
      </p:grpSp>
      <p:grpSp>
        <p:nvGrpSpPr>
          <p:cNvPr id="79" name="Group 78"/>
          <p:cNvGrpSpPr/>
          <p:nvPr/>
        </p:nvGrpSpPr>
        <p:grpSpPr>
          <a:xfrm>
            <a:off x="4647778" y="491642"/>
            <a:ext cx="2568455" cy="2787946"/>
            <a:chOff x="4517999" y="459992"/>
            <a:chExt cx="3103761" cy="3368997"/>
          </a:xfrm>
        </p:grpSpPr>
        <p:pic>
          <p:nvPicPr>
            <p:cNvPr id="62" name="Picture 61"/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111" t="32465" r="46280" b="25321"/>
            <a:stretch/>
          </p:blipFill>
          <p:spPr>
            <a:xfrm flipH="1">
              <a:off x="4517999" y="1012440"/>
              <a:ext cx="1447682" cy="281654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9ABAE885-CDC2-4ED8-BB92-2AFC89096EC3}"/>
                </a:ext>
              </a:extLst>
            </p:cNvPr>
            <p:cNvSpPr/>
            <p:nvPr/>
          </p:nvSpPr>
          <p:spPr>
            <a:xfrm>
              <a:off x="4572058" y="459992"/>
              <a:ext cx="304970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D-</a:t>
              </a:r>
              <a:r>
                <a:rPr lang="el-GR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400" b="1" dirty="0">
                  <a:solidFill>
                    <a:sysClr val="windowText" lastClr="000000"/>
                  </a:solidFill>
                  <a:effectLst>
                    <a:outerShdw blurRad="38100" dist="38100" dir="2700000" algn="tl" rotWithShape="0">
                      <a:srgbClr val="C0C0C0"/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(1-18)N-Ter-Antp, </a:t>
              </a:r>
              <a:r>
                <a:rPr lang="en-US" sz="1400" b="1" dirty="0">
                  <a:latin typeface="Symbol" panose="05050102010706020507" pitchFamily="18" charset="2"/>
                  <a:cs typeface="Times New Roman" panose="02020603050405020304" pitchFamily="18" charset="0"/>
                </a:rPr>
                <a:t>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7501C4F3-ACEC-488B-84BD-1DAB413FEA94}"/>
                </a:ext>
              </a:extLst>
            </p:cNvPr>
            <p:cNvSpPr/>
            <p:nvPr/>
          </p:nvSpPr>
          <p:spPr>
            <a:xfrm>
              <a:off x="4759133" y="758602"/>
              <a:ext cx="17267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 7.5        15     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he-IL" sz="1200" dirty="0"/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C848D63B-3339-416C-B136-A7D39D669266}"/>
                </a:ext>
              </a:extLst>
            </p:cNvPr>
            <p:cNvSpPr/>
            <p:nvPr/>
          </p:nvSpPr>
          <p:spPr>
            <a:xfrm>
              <a:off x="5965681" y="2657778"/>
              <a:ext cx="656435" cy="28866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76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4   </a:t>
              </a:r>
              <a:endParaRPr lang="he-IL" sz="127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1" name="Rectangle 80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1186485" y="3011336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C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3270721" y="3051358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C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5273064" y="3056900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C</a:t>
            </a: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5583843" y="6123214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C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3409209" y="6136203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C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1326289" y="6085015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C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1157186" y="9320434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C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86" t="34255" r="44000" b="23754"/>
          <a:stretch/>
        </p:blipFill>
        <p:spPr>
          <a:xfrm>
            <a:off x="2807505" y="7248186"/>
            <a:ext cx="1214846" cy="244445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6" name="Rectangle 65">
            <a:extLst>
              <a:ext uri="{FF2B5EF4-FFF2-40B4-BE49-F238E27FC236}">
                <a16:creationId xmlns:a16="http://schemas.microsoft.com/office/drawing/2014/main" id="{9ABAE885-CDC2-4ED8-BB92-2AFC89096EC3}"/>
              </a:ext>
            </a:extLst>
          </p:cNvPr>
          <p:cNvSpPr/>
          <p:nvPr/>
        </p:nvSpPr>
        <p:spPr>
          <a:xfrm>
            <a:off x="2791068" y="6747867"/>
            <a:ext cx="2523719" cy="2546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ysClr val="windowText" lastClr="000000"/>
                </a:solidFill>
                <a:effectLst>
                  <a:outerShdw blurRad="38100" dist="38100" dir="2700000" algn="tl" rotWithShape="0">
                    <a:srgbClr val="C0C0C0"/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D-</a:t>
            </a:r>
            <a:r>
              <a:rPr lang="el-GR" sz="1400" b="1" dirty="0">
                <a:solidFill>
                  <a:sysClr val="windowText" lastClr="000000"/>
                </a:solidFill>
                <a:effectLst>
                  <a:outerShdw blurRad="38100" dist="38100" dir="2700000" algn="tl" rotWithShape="0">
                    <a:srgbClr val="C0C0C0"/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400" b="1" dirty="0">
                <a:solidFill>
                  <a:sysClr val="windowText" lastClr="000000"/>
                </a:solidFill>
                <a:effectLst>
                  <a:outerShdw blurRad="38100" dist="38100" dir="2700000" algn="tl" rotWithShape="0">
                    <a:srgbClr val="C0C0C0"/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(1-18)N-Ter-Antp, </a:t>
            </a:r>
            <a:r>
              <a:rPr lang="en-US" sz="1400" b="1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7501C4F3-ACEC-488B-84BD-1DAB413FEA94}"/>
              </a:ext>
            </a:extLst>
          </p:cNvPr>
          <p:cNvSpPr/>
          <p:nvPr/>
        </p:nvSpPr>
        <p:spPr>
          <a:xfrm>
            <a:off x="2906833" y="7000990"/>
            <a:ext cx="1365268" cy="2292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  7.5      15     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he-IL" sz="1200" dirty="0"/>
          </a:p>
        </p:txBody>
      </p:sp>
      <p:sp>
        <p:nvSpPr>
          <p:cNvPr id="74" name="TextBox 73"/>
          <p:cNvSpPr txBox="1"/>
          <p:nvPr/>
        </p:nvSpPr>
        <p:spPr>
          <a:xfrm>
            <a:off x="4016940" y="8350972"/>
            <a:ext cx="703469" cy="2886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7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D047E9F9-A382-4DD4-9FD7-51066CC1AD5D}"/>
              </a:ext>
            </a:extLst>
          </p:cNvPr>
          <p:cNvSpPr/>
          <p:nvPr/>
        </p:nvSpPr>
        <p:spPr>
          <a:xfrm>
            <a:off x="1817166" y="8225021"/>
            <a:ext cx="1049570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l-GR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 </a:t>
            </a:r>
            <a:endParaRPr lang="he-IL" sz="148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A491B5EF-75D1-4133-8FD7-9AA103B97C53}"/>
              </a:ext>
            </a:extLst>
          </p:cNvPr>
          <p:cNvSpPr/>
          <p:nvPr/>
        </p:nvSpPr>
        <p:spPr>
          <a:xfrm>
            <a:off x="3473528" y="9438900"/>
            <a:ext cx="1362618" cy="321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8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3. C</a:t>
            </a:r>
          </a:p>
        </p:txBody>
      </p:sp>
    </p:spTree>
    <p:extLst>
      <p:ext uri="{BB962C8B-B14F-4D97-AF65-F5344CB8AC3E}">
        <p14:creationId xmlns:p14="http://schemas.microsoft.com/office/powerpoint/2010/main" val="38077961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</TotalTime>
  <Words>395</Words>
  <Application>Microsoft Office PowerPoint</Application>
  <PresentationFormat>A4 Paper (210x297 mm)</PresentationFormat>
  <Paragraphs>1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אנה קוזמין שטיינפר</dc:creator>
  <cp:lastModifiedBy>Uzoamaka Anyanwu</cp:lastModifiedBy>
  <cp:revision>13</cp:revision>
  <dcterms:created xsi:type="dcterms:W3CDTF">2022-08-15T07:43:50Z</dcterms:created>
  <dcterms:modified xsi:type="dcterms:W3CDTF">2022-08-24T09:35:48Z</dcterms:modified>
</cp:coreProperties>
</file>